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Default Extension="37-1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63" r:id="rId3"/>
    <p:sldId id="260" r:id="rId4"/>
    <p:sldId id="261" r:id="rId5"/>
    <p:sldId id="258" r:id="rId6"/>
    <p:sldId id="259" r:id="rId7"/>
    <p:sldId id="257" r:id="rId8"/>
    <p:sldId id="256" r:id="rId9"/>
    <p:sldId id="266" r:id="rId10"/>
    <p:sldId id="267" r:id="rId11"/>
    <p:sldId id="264" r:id="rId12"/>
    <p:sldId id="265" r:id="rId1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24"/>
    <p:restoredTop sz="94671"/>
  </p:normalViewPr>
  <p:slideViewPr>
    <p:cSldViewPr snapToGrid="0" snapToObjects="1">
      <p:cViewPr varScale="1">
        <p:scale>
          <a:sx n="111" d="100"/>
          <a:sy n="111" d="100"/>
        </p:scale>
        <p:origin x="11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201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259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8078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2835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293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3495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0276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035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91988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6359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6080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EACDC-0843-F140-B63F-D978B1C2B428}" type="datetimeFigureOut">
              <a:rPr kumimoji="1" lang="ja-JP" altLang="en-US" smtClean="0"/>
              <a:t>2020/9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E88E6-8E9F-5245-A9FD-8393D094837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3564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jpg"/><Relationship Id="rId2" Type="http://schemas.openxmlformats.org/officeDocument/2006/relationships/image" Target="../media/image37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0.jpg"/><Relationship Id="rId4" Type="http://schemas.openxmlformats.org/officeDocument/2006/relationships/image" Target="../media/image39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g"/><Relationship Id="rId2" Type="http://schemas.openxmlformats.org/officeDocument/2006/relationships/image" Target="../media/image4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4.jpg"/><Relationship Id="rId4" Type="http://schemas.openxmlformats.org/officeDocument/2006/relationships/image" Target="../media/image43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jpg"/><Relationship Id="rId2" Type="http://schemas.openxmlformats.org/officeDocument/2006/relationships/image" Target="../media/image45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8.jpg"/><Relationship Id="rId4" Type="http://schemas.openxmlformats.org/officeDocument/2006/relationships/image" Target="../media/image47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jpg"/><Relationship Id="rId4" Type="http://schemas.openxmlformats.org/officeDocument/2006/relationships/image" Target="../media/image1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37-1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jpg"/><Relationship Id="rId4" Type="http://schemas.openxmlformats.org/officeDocument/2006/relationships/image" Target="../media/image23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g"/><Relationship Id="rId2" Type="http://schemas.openxmlformats.org/officeDocument/2006/relationships/image" Target="../media/image33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6.jpg"/><Relationship Id="rId4" Type="http://schemas.openxmlformats.org/officeDocument/2006/relationships/image" Target="../media/image3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92663CE4-5519-B34A-AA0C-F0AA4DFDA0F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1021559"/>
            <a:ext cx="3406172" cy="340617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CAF3BCA-91ED-6C46-AD0E-587587E002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51828" y="1021559"/>
            <a:ext cx="3406172" cy="340617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C427514-BA43-6C46-95B1-F0D27886EF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6130496"/>
            <a:ext cx="3406172" cy="3406172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16F69471-D298-B345-96E6-FE7A41B400B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51828" y="6130496"/>
            <a:ext cx="3406172" cy="3406172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6E68658-8C58-6B45-838F-478D20171CF3}"/>
              </a:ext>
            </a:extLst>
          </p:cNvPr>
          <p:cNvSpPr txBox="1"/>
          <p:nvPr/>
        </p:nvSpPr>
        <p:spPr>
          <a:xfrm>
            <a:off x="414755" y="4366647"/>
            <a:ext cx="3014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/>
              <a:t>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a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D235B37-E2AA-154E-BF83-00FB077187C9}"/>
              </a:ext>
            </a:extLst>
          </p:cNvPr>
          <p:cNvSpPr txBox="1"/>
          <p:nvPr/>
        </p:nvSpPr>
        <p:spPr>
          <a:xfrm>
            <a:off x="3924923" y="4427731"/>
            <a:ext cx="2836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b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4F6AD9B-FE7E-A54C-937C-8B1D29CE5C14}"/>
              </a:ext>
            </a:extLst>
          </p:cNvPr>
          <p:cNvSpPr txBox="1"/>
          <p:nvPr/>
        </p:nvSpPr>
        <p:spPr>
          <a:xfrm>
            <a:off x="638942" y="9529597"/>
            <a:ext cx="2812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c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10237FF-C957-C842-8A20-21A5F3400475}"/>
              </a:ext>
            </a:extLst>
          </p:cNvPr>
          <p:cNvSpPr txBox="1"/>
          <p:nvPr/>
        </p:nvSpPr>
        <p:spPr>
          <a:xfrm>
            <a:off x="4090770" y="9536668"/>
            <a:ext cx="2836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d</a:t>
            </a:r>
            <a:endParaRPr kumimoji="1" lang="ja-JP" altLang="en-US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996A274-3238-394D-9D8A-723E88596385}"/>
              </a:ext>
            </a:extLst>
          </p:cNvPr>
          <p:cNvSpPr/>
          <p:nvPr/>
        </p:nvSpPr>
        <p:spPr>
          <a:xfrm>
            <a:off x="0" y="31913"/>
            <a:ext cx="4573368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Untre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GFAP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13895939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E593297B-03FE-B944-832F-01D9822F83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1023074"/>
            <a:ext cx="3410030" cy="3410030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608C4B3-FEDB-A743-9EC0-1542AFA6CB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4046" y="1023074"/>
            <a:ext cx="3410030" cy="341003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7640DE7-9602-5C48-8D9D-E1860B9ACD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855826"/>
            <a:ext cx="3410030" cy="3410030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0ADA56A-D641-9C4B-ADC9-2B0042D0DE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7970" y="5855826"/>
            <a:ext cx="3410030" cy="341003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2260982-E1F4-1449-97DF-C8E48E5EF634}"/>
              </a:ext>
            </a:extLst>
          </p:cNvPr>
          <p:cNvSpPr txBox="1"/>
          <p:nvPr/>
        </p:nvSpPr>
        <p:spPr>
          <a:xfrm>
            <a:off x="727659" y="4433104"/>
            <a:ext cx="23815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e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B3C083D-6BF9-D346-BFD2-2668B1B16587}"/>
              </a:ext>
            </a:extLst>
          </p:cNvPr>
          <p:cNvSpPr txBox="1"/>
          <p:nvPr/>
        </p:nvSpPr>
        <p:spPr>
          <a:xfrm>
            <a:off x="3916749" y="4433104"/>
            <a:ext cx="2334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f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AA0497B-F1FE-134E-B009-AEC084BC9592}"/>
              </a:ext>
            </a:extLst>
          </p:cNvPr>
          <p:cNvSpPr txBox="1"/>
          <p:nvPr/>
        </p:nvSpPr>
        <p:spPr>
          <a:xfrm>
            <a:off x="4181680" y="9265856"/>
            <a:ext cx="2387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h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9A8E5C2-D592-2640-A473-9675AB90E4A5}"/>
              </a:ext>
            </a:extLst>
          </p:cNvPr>
          <p:cNvSpPr txBox="1"/>
          <p:nvPr/>
        </p:nvSpPr>
        <p:spPr>
          <a:xfrm>
            <a:off x="897034" y="9265856"/>
            <a:ext cx="2375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g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BF8A1796-FA57-B34D-9C3A-083044B2486B}"/>
              </a:ext>
            </a:extLst>
          </p:cNvPr>
          <p:cNvSpPr/>
          <p:nvPr/>
        </p:nvSpPr>
        <p:spPr>
          <a:xfrm>
            <a:off x="0" y="31913"/>
            <a:ext cx="417960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Untre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O4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18524347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0008416-CCB2-264A-90CB-D2586F2D73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25975"/>
            <a:ext cx="3386238" cy="338623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D04860CE-4880-1147-BCFE-55E67D2A8A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1762" y="925975"/>
            <a:ext cx="3386238" cy="338623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4BEEEAD-5B4A-D244-AE12-15849B48C1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878975"/>
            <a:ext cx="3386238" cy="338623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35DBB5DD-6962-2A49-981E-0A62CAD04F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71762" y="5878975"/>
            <a:ext cx="3386238" cy="338623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C8CAA14-1FEF-FD4B-B465-D9C993DA8244}"/>
              </a:ext>
            </a:extLst>
          </p:cNvPr>
          <p:cNvSpPr txBox="1"/>
          <p:nvPr/>
        </p:nvSpPr>
        <p:spPr>
          <a:xfrm>
            <a:off x="1193299" y="4379650"/>
            <a:ext cx="2044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a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72CB562-2647-1049-B34C-4485A99DB241}"/>
              </a:ext>
            </a:extLst>
          </p:cNvPr>
          <p:cNvSpPr txBox="1"/>
          <p:nvPr/>
        </p:nvSpPr>
        <p:spPr>
          <a:xfrm>
            <a:off x="4436139" y="4383540"/>
            <a:ext cx="2055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b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17EB1A6-452D-894A-94F9-25A80028E4E7}"/>
              </a:ext>
            </a:extLst>
          </p:cNvPr>
          <p:cNvSpPr txBox="1"/>
          <p:nvPr/>
        </p:nvSpPr>
        <p:spPr>
          <a:xfrm>
            <a:off x="1067906" y="9182615"/>
            <a:ext cx="2031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c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3B18654-1387-8D4A-9C70-3FA0A694966C}"/>
              </a:ext>
            </a:extLst>
          </p:cNvPr>
          <p:cNvSpPr txBox="1"/>
          <p:nvPr/>
        </p:nvSpPr>
        <p:spPr>
          <a:xfrm>
            <a:off x="4675991" y="9232804"/>
            <a:ext cx="2055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d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23A131C9-F1B6-F246-8C23-4FFB246C1B72}"/>
              </a:ext>
            </a:extLst>
          </p:cNvPr>
          <p:cNvSpPr/>
          <p:nvPr/>
        </p:nvSpPr>
        <p:spPr>
          <a:xfrm>
            <a:off x="0" y="31913"/>
            <a:ext cx="405213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Oper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O4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23573664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E96FA50A-AE0E-0641-AEA4-13E584AA3F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50065"/>
            <a:ext cx="3379808" cy="337980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5C95B27-2857-3742-BAE8-896B2006F4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8192" y="1250065"/>
            <a:ext cx="3379808" cy="337980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3505FA7D-7907-E84D-AB62-7C52F4CC697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112" y="5745543"/>
            <a:ext cx="3379808" cy="337980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94FD349-40FE-3941-826D-2F4FB46B22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78192" y="5745543"/>
            <a:ext cx="3379808" cy="337980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BF34461-AACF-3349-8A74-96051652F0E1}"/>
              </a:ext>
            </a:extLst>
          </p:cNvPr>
          <p:cNvSpPr txBox="1"/>
          <p:nvPr/>
        </p:nvSpPr>
        <p:spPr>
          <a:xfrm>
            <a:off x="1193299" y="4703740"/>
            <a:ext cx="2048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e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2642EBA-64D8-C64F-AAF1-519D16025FC7}"/>
              </a:ext>
            </a:extLst>
          </p:cNvPr>
          <p:cNvSpPr txBox="1"/>
          <p:nvPr/>
        </p:nvSpPr>
        <p:spPr>
          <a:xfrm>
            <a:off x="4457359" y="4627943"/>
            <a:ext cx="20020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f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FF066390-873B-FD41-A261-B94A7D42D428}"/>
              </a:ext>
            </a:extLst>
          </p:cNvPr>
          <p:cNvSpPr txBox="1"/>
          <p:nvPr/>
        </p:nvSpPr>
        <p:spPr>
          <a:xfrm>
            <a:off x="1199711" y="9125351"/>
            <a:ext cx="20425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g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97B2F42-F82F-9142-AA40-BE8F452F9D78}"/>
              </a:ext>
            </a:extLst>
          </p:cNvPr>
          <p:cNvSpPr txBox="1"/>
          <p:nvPr/>
        </p:nvSpPr>
        <p:spPr>
          <a:xfrm>
            <a:off x="4404011" y="9125351"/>
            <a:ext cx="20553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h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EFA0CF7B-4B18-EF4D-B664-D8B9F1FFC0CF}"/>
              </a:ext>
            </a:extLst>
          </p:cNvPr>
          <p:cNvSpPr/>
          <p:nvPr/>
        </p:nvSpPr>
        <p:spPr>
          <a:xfrm>
            <a:off x="0" y="31913"/>
            <a:ext cx="405213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Oper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O4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12762723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DB46387-3EDF-634B-AD15-BB5E9A35FD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38" y="859903"/>
            <a:ext cx="3386881" cy="3386881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707678AF-E332-2E43-8E42-DFD676A7DB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9157" y="859903"/>
            <a:ext cx="3386881" cy="338688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523588B6-AED3-0045-A9FA-673AE49F5C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699245"/>
            <a:ext cx="3386881" cy="338688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25EA73AC-D261-6648-8DBD-2AF3B73DCF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72242" y="5692330"/>
            <a:ext cx="3393796" cy="3393796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6648293-5DB4-0A48-A14C-EE20F471E668}"/>
              </a:ext>
            </a:extLst>
          </p:cNvPr>
          <p:cNvSpPr txBox="1"/>
          <p:nvPr/>
        </p:nvSpPr>
        <p:spPr>
          <a:xfrm>
            <a:off x="564401" y="4222830"/>
            <a:ext cx="2830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e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40433A3-62E8-9246-B8EC-5BDB1DA114F5}"/>
              </a:ext>
            </a:extLst>
          </p:cNvPr>
          <p:cNvSpPr txBox="1"/>
          <p:nvPr/>
        </p:nvSpPr>
        <p:spPr>
          <a:xfrm>
            <a:off x="4082455" y="4221705"/>
            <a:ext cx="27835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f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1442D2F-2670-DD43-A9FC-61000EA7580E}"/>
              </a:ext>
            </a:extLst>
          </p:cNvPr>
          <p:cNvSpPr txBox="1"/>
          <p:nvPr/>
        </p:nvSpPr>
        <p:spPr>
          <a:xfrm>
            <a:off x="400270" y="9067395"/>
            <a:ext cx="30292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O</a:t>
            </a:r>
            <a:r>
              <a:rPr lang="en-US" altLang="ja-JP" dirty="0"/>
              <a:t> 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g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2CC6608-4C29-7747-BDBC-3E5298984B1D}"/>
              </a:ext>
            </a:extLst>
          </p:cNvPr>
          <p:cNvSpPr txBox="1"/>
          <p:nvPr/>
        </p:nvSpPr>
        <p:spPr>
          <a:xfrm>
            <a:off x="4029108" y="9067395"/>
            <a:ext cx="2836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Untreated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h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3D6DB9CD-D1FD-4442-85BC-E1A5A8E727DA}"/>
              </a:ext>
            </a:extLst>
          </p:cNvPr>
          <p:cNvSpPr/>
          <p:nvPr/>
        </p:nvSpPr>
        <p:spPr>
          <a:xfrm>
            <a:off x="0" y="31913"/>
            <a:ext cx="4573368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Untre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GFAP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2581093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D14B18F1-ECA4-4246-9544-C57D823ADE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891252"/>
            <a:ext cx="3379808" cy="337980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9D50BF9-632E-3B4B-95A2-52049B6330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8192" y="891252"/>
            <a:ext cx="3379808" cy="337980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21828C3-D424-4846-AEE0-8BBD8F57E5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" y="6034914"/>
            <a:ext cx="3379808" cy="337980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2C8FB344-C044-5C42-BC65-EEC765B02F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78192" y="6034914"/>
            <a:ext cx="3379808" cy="337980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FD91AC0-53C6-5E45-9660-B482C6B5EEEF}"/>
              </a:ext>
            </a:extLst>
          </p:cNvPr>
          <p:cNvSpPr txBox="1"/>
          <p:nvPr/>
        </p:nvSpPr>
        <p:spPr>
          <a:xfrm>
            <a:off x="937549" y="4344926"/>
            <a:ext cx="2481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a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E88F021-1B36-6440-8531-42B78A4AF88D}"/>
              </a:ext>
            </a:extLst>
          </p:cNvPr>
          <p:cNvSpPr txBox="1"/>
          <p:nvPr/>
        </p:nvSpPr>
        <p:spPr>
          <a:xfrm>
            <a:off x="4457359" y="4269129"/>
            <a:ext cx="2269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b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90EE617-6B21-4440-863C-B622A7ADFDAF}"/>
              </a:ext>
            </a:extLst>
          </p:cNvPr>
          <p:cNvSpPr txBox="1"/>
          <p:nvPr/>
        </p:nvSpPr>
        <p:spPr>
          <a:xfrm>
            <a:off x="1193299" y="9414722"/>
            <a:ext cx="22455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c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3D62ABB5-0456-9C48-B9CD-744DCE84545B}"/>
              </a:ext>
            </a:extLst>
          </p:cNvPr>
          <p:cNvSpPr txBox="1"/>
          <p:nvPr/>
        </p:nvSpPr>
        <p:spPr>
          <a:xfrm>
            <a:off x="4457359" y="9414722"/>
            <a:ext cx="2269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d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B7D46BA2-57F4-0E48-A263-A8513BECD5CB}"/>
              </a:ext>
            </a:extLst>
          </p:cNvPr>
          <p:cNvSpPr/>
          <p:nvPr/>
        </p:nvSpPr>
        <p:spPr>
          <a:xfrm>
            <a:off x="0" y="31913"/>
            <a:ext cx="444589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Oper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GFAP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16936679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01C518FD-F142-394E-8F9C-BBFE54410E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79" y="1134320"/>
            <a:ext cx="3395163" cy="337530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8916921A-CB62-5240-828B-59ACEBC3B4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2692" y="1134320"/>
            <a:ext cx="3375308" cy="337530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77E4B83-9EE4-3649-A53C-2B01C7098F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17" y="5780912"/>
            <a:ext cx="3375308" cy="337530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C4EA5021-9FB7-4D4F-8790-BAAD50C8A5C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82692" y="5780912"/>
            <a:ext cx="3375308" cy="3375308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5E3A1E5-2BC3-4140-A9FF-20F22E43133E}"/>
              </a:ext>
            </a:extLst>
          </p:cNvPr>
          <p:cNvSpPr txBox="1"/>
          <p:nvPr/>
        </p:nvSpPr>
        <p:spPr>
          <a:xfrm>
            <a:off x="1211378" y="4587994"/>
            <a:ext cx="2263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e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44584AB-531F-A144-A13D-56AB4951BB43}"/>
              </a:ext>
            </a:extLst>
          </p:cNvPr>
          <p:cNvSpPr txBox="1"/>
          <p:nvPr/>
        </p:nvSpPr>
        <p:spPr>
          <a:xfrm>
            <a:off x="4475438" y="4512197"/>
            <a:ext cx="2216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f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7F1C709-D608-3D43-B20D-4F4FFD46E6BE}"/>
              </a:ext>
            </a:extLst>
          </p:cNvPr>
          <p:cNvSpPr txBox="1"/>
          <p:nvPr/>
        </p:nvSpPr>
        <p:spPr>
          <a:xfrm>
            <a:off x="1257033" y="9236597"/>
            <a:ext cx="2256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g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A8B74B6-778F-BC4B-AC2C-5A0721036797}"/>
              </a:ext>
            </a:extLst>
          </p:cNvPr>
          <p:cNvSpPr txBox="1"/>
          <p:nvPr/>
        </p:nvSpPr>
        <p:spPr>
          <a:xfrm>
            <a:off x="4475438" y="9241016"/>
            <a:ext cx="2269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GFAP</a:t>
            </a:r>
            <a:r>
              <a:rPr lang="en-US" altLang="ja-JP" dirty="0"/>
              <a:t>-h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7D66BD22-78CB-6C43-B211-3F1D83DC834F}"/>
              </a:ext>
            </a:extLst>
          </p:cNvPr>
          <p:cNvSpPr/>
          <p:nvPr/>
        </p:nvSpPr>
        <p:spPr>
          <a:xfrm>
            <a:off x="0" y="31913"/>
            <a:ext cx="4445897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Oper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GFAP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4320371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5A92820-15BD-454A-897A-2B1D9567EB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937549"/>
            <a:ext cx="3395604" cy="3395604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CBADF6B4-0532-F442-A5F7-4F5E12FEF8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2823" y="937549"/>
            <a:ext cx="3395604" cy="339560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A5227207-419D-8E4E-80F6-8865EA5105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537200"/>
            <a:ext cx="3395604" cy="3395604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1B76209E-1FDD-7147-8B46-86017C780EB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1540" y="5537200"/>
            <a:ext cx="3410030" cy="3410030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35F7770-819D-1143-A340-1FCBBB31AE8E}"/>
              </a:ext>
            </a:extLst>
          </p:cNvPr>
          <p:cNvSpPr txBox="1"/>
          <p:nvPr/>
        </p:nvSpPr>
        <p:spPr>
          <a:xfrm>
            <a:off x="938012" y="4333153"/>
            <a:ext cx="2514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a</a:t>
            </a:r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02CEEA1-C621-754F-8D1D-B464BE0C5356}"/>
              </a:ext>
            </a:extLst>
          </p:cNvPr>
          <p:cNvSpPr txBox="1"/>
          <p:nvPr/>
        </p:nvSpPr>
        <p:spPr>
          <a:xfrm>
            <a:off x="4323827" y="4333153"/>
            <a:ext cx="2525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b</a:t>
            </a:r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7EA0B20-6356-0546-8214-33BFAAFFBCB6}"/>
              </a:ext>
            </a:extLst>
          </p:cNvPr>
          <p:cNvSpPr txBox="1"/>
          <p:nvPr/>
        </p:nvSpPr>
        <p:spPr>
          <a:xfrm>
            <a:off x="733525" y="8932804"/>
            <a:ext cx="2501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c</a:t>
            </a:r>
            <a:endParaRPr kumimoji="1" lang="ja-JP" altLang="en-US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A3C77906-CAF1-644D-A3FB-5F7DB4B44208}"/>
              </a:ext>
            </a:extLst>
          </p:cNvPr>
          <p:cNvSpPr txBox="1"/>
          <p:nvPr/>
        </p:nvSpPr>
        <p:spPr>
          <a:xfrm>
            <a:off x="4323828" y="8947230"/>
            <a:ext cx="2525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d</a:t>
            </a:r>
            <a:endParaRPr kumimoji="1" lang="ja-JP" altLang="en-US"/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6F01A9C3-3E3B-AE4B-BC91-BEB70593A4C1}"/>
              </a:ext>
            </a:extLst>
          </p:cNvPr>
          <p:cNvSpPr/>
          <p:nvPr/>
        </p:nvSpPr>
        <p:spPr>
          <a:xfrm>
            <a:off x="0" y="31913"/>
            <a:ext cx="442486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Untre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Iba1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22127983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7E56BD6-1BFD-7D46-92A7-68B9D6F89D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30147"/>
            <a:ext cx="3410673" cy="341067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494315F6-82C6-ED4B-A516-DAAB26EA0D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7326" y="1030147"/>
            <a:ext cx="3410673" cy="3410673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A4A33990-93FB-A148-A36B-C9F9F293CF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155236"/>
            <a:ext cx="3410673" cy="3410673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9592F32A-7855-B748-9867-9F35A8F7AEE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7327" y="5155236"/>
            <a:ext cx="3410673" cy="3410673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D309106-E73A-6A42-B677-8E201783924D}"/>
              </a:ext>
            </a:extLst>
          </p:cNvPr>
          <p:cNvSpPr txBox="1"/>
          <p:nvPr/>
        </p:nvSpPr>
        <p:spPr>
          <a:xfrm>
            <a:off x="938012" y="4425751"/>
            <a:ext cx="2519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e</a:t>
            </a:r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D71003F-FE37-4D4D-80B7-F7827CFB6EC0}"/>
              </a:ext>
            </a:extLst>
          </p:cNvPr>
          <p:cNvSpPr txBox="1"/>
          <p:nvPr/>
        </p:nvSpPr>
        <p:spPr>
          <a:xfrm>
            <a:off x="3898005" y="4421162"/>
            <a:ext cx="24724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f</a:t>
            </a:r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92344B3-0618-0D42-9632-777ECB8A1BEA}"/>
              </a:ext>
            </a:extLst>
          </p:cNvPr>
          <p:cNvSpPr txBox="1"/>
          <p:nvPr/>
        </p:nvSpPr>
        <p:spPr>
          <a:xfrm>
            <a:off x="4378450" y="8556730"/>
            <a:ext cx="2525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h</a:t>
            </a:r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ADCD783-430C-894B-8F20-B153DA6ECECE}"/>
              </a:ext>
            </a:extLst>
          </p:cNvPr>
          <p:cNvSpPr txBox="1"/>
          <p:nvPr/>
        </p:nvSpPr>
        <p:spPr>
          <a:xfrm>
            <a:off x="932727" y="8556730"/>
            <a:ext cx="2512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g</a:t>
            </a:r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5D47ED04-811F-1F49-8353-49AE8285F7D6}"/>
              </a:ext>
            </a:extLst>
          </p:cNvPr>
          <p:cNvSpPr/>
          <p:nvPr/>
        </p:nvSpPr>
        <p:spPr>
          <a:xfrm>
            <a:off x="0" y="31913"/>
            <a:ext cx="442486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Untre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Iba1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25264217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41C2C53-4C7E-4C45-9570-882C671D51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-11220" y="5849716"/>
            <a:ext cx="3375307" cy="3375307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1FF7467-038C-CB4F-9D80-25E232F9F5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10800000">
            <a:off x="3491328" y="1093646"/>
            <a:ext cx="3355452" cy="3355452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6A3A56CD-AA5C-BE42-800D-88773CE4C70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-11220" y="1093646"/>
            <a:ext cx="3434871" cy="3355452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78987AA3-B5B7-5C48-B4DA-18600C42272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71472" y="5849716"/>
            <a:ext cx="3375307" cy="3375307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8C55450-B1B7-504D-9954-976044554E28}"/>
              </a:ext>
            </a:extLst>
          </p:cNvPr>
          <p:cNvSpPr txBox="1"/>
          <p:nvPr/>
        </p:nvSpPr>
        <p:spPr>
          <a:xfrm>
            <a:off x="1182079" y="4449098"/>
            <a:ext cx="21820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a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3E8B7BC-B758-354B-A008-05363DC4B37B}"/>
              </a:ext>
            </a:extLst>
          </p:cNvPr>
          <p:cNvSpPr txBox="1"/>
          <p:nvPr/>
        </p:nvSpPr>
        <p:spPr>
          <a:xfrm>
            <a:off x="4424919" y="4452988"/>
            <a:ext cx="2193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b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6BFC825-7799-2D4C-A070-C72DFCD7C16B}"/>
              </a:ext>
            </a:extLst>
          </p:cNvPr>
          <p:cNvSpPr txBox="1"/>
          <p:nvPr/>
        </p:nvSpPr>
        <p:spPr>
          <a:xfrm>
            <a:off x="1056686" y="9252063"/>
            <a:ext cx="21691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c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84D9F15-D8BE-374A-ABB1-09E212970E73}"/>
              </a:ext>
            </a:extLst>
          </p:cNvPr>
          <p:cNvSpPr txBox="1"/>
          <p:nvPr/>
        </p:nvSpPr>
        <p:spPr>
          <a:xfrm>
            <a:off x="4664771" y="9302252"/>
            <a:ext cx="2193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d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96B9464B-0014-C441-9B88-4350C0F66AC8}"/>
              </a:ext>
            </a:extLst>
          </p:cNvPr>
          <p:cNvSpPr/>
          <p:nvPr/>
        </p:nvSpPr>
        <p:spPr>
          <a:xfrm>
            <a:off x="0" y="31913"/>
            <a:ext cx="429739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Oper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Iba1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27759773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99D78887-AAFF-9A4F-9B0B-53196A716E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63405" y="5858719"/>
            <a:ext cx="3377878" cy="337787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ECB52A0-66CE-034F-A964-B8948409339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0" y="5858719"/>
            <a:ext cx="3377878" cy="337787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75537121-578F-FF46-B471-FE225EF5C49B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74980" y="1134319"/>
            <a:ext cx="3377878" cy="337787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C02615E9-BA91-B249-813D-088236E4954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3084" y="1134319"/>
            <a:ext cx="3377878" cy="337787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3BA75AD-C200-AF42-AA9A-24286471975F}"/>
              </a:ext>
            </a:extLst>
          </p:cNvPr>
          <p:cNvSpPr txBox="1"/>
          <p:nvPr/>
        </p:nvSpPr>
        <p:spPr>
          <a:xfrm>
            <a:off x="1193299" y="4587994"/>
            <a:ext cx="21868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GPR37L1-Iba1-e</a:t>
            </a:r>
            <a:endParaRPr kumimoji="1" lang="ja-JP" altLang="en-US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C36EE18-F7CB-0244-97EB-E0049E393B0D}"/>
              </a:ext>
            </a:extLst>
          </p:cNvPr>
          <p:cNvSpPr txBox="1"/>
          <p:nvPr/>
        </p:nvSpPr>
        <p:spPr>
          <a:xfrm>
            <a:off x="1193299" y="4587994"/>
            <a:ext cx="20714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</a:t>
            </a:r>
            <a:endParaRPr kumimoji="1"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C90FE21-67B9-7748-B446-019223A1AEEA}"/>
              </a:ext>
            </a:extLst>
          </p:cNvPr>
          <p:cNvSpPr txBox="1"/>
          <p:nvPr/>
        </p:nvSpPr>
        <p:spPr>
          <a:xfrm>
            <a:off x="4457359" y="4512197"/>
            <a:ext cx="2139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f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E25B2A3-1DA5-B84D-9624-18780D8B6E20}"/>
              </a:ext>
            </a:extLst>
          </p:cNvPr>
          <p:cNvSpPr txBox="1"/>
          <p:nvPr/>
        </p:nvSpPr>
        <p:spPr>
          <a:xfrm>
            <a:off x="1238954" y="9236597"/>
            <a:ext cx="21804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g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754E1FC-7618-6A4A-9E1C-CD92307E8A80}"/>
              </a:ext>
            </a:extLst>
          </p:cNvPr>
          <p:cNvSpPr txBox="1"/>
          <p:nvPr/>
        </p:nvSpPr>
        <p:spPr>
          <a:xfrm>
            <a:off x="4457359" y="9241016"/>
            <a:ext cx="2193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err="1"/>
              <a:t>Ope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Iba1</a:t>
            </a:r>
            <a:r>
              <a:rPr lang="en-US" altLang="ja-JP" dirty="0"/>
              <a:t>-h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AF43CB06-DC62-9745-983B-7E5C145724C8}"/>
              </a:ext>
            </a:extLst>
          </p:cNvPr>
          <p:cNvSpPr/>
          <p:nvPr/>
        </p:nvSpPr>
        <p:spPr>
          <a:xfrm>
            <a:off x="0" y="31913"/>
            <a:ext cx="4297395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Oper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Iba1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19280739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76E337DF-883E-6D42-B952-6EE3A842EC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64" y="1180617"/>
            <a:ext cx="3411541" cy="342160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7A9757E8-9C07-3840-8871-4523D04B25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46459" y="1180617"/>
            <a:ext cx="3421605" cy="3421605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067940DD-745C-2748-A073-0896AF76ED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629796"/>
            <a:ext cx="3421605" cy="3421605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6C6AEAA6-BD4B-084B-858B-856365A39A1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46458" y="5629796"/>
            <a:ext cx="3421605" cy="3421605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9C00739-D788-3042-AF68-3FFB6B107813}"/>
              </a:ext>
            </a:extLst>
          </p:cNvPr>
          <p:cNvSpPr txBox="1"/>
          <p:nvPr/>
        </p:nvSpPr>
        <p:spPr>
          <a:xfrm>
            <a:off x="948076" y="4576221"/>
            <a:ext cx="2376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a</a:t>
            </a:r>
            <a:endParaRPr kumimoji="1" lang="ja-JP" altLang="en-US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791ABB7-B290-0B41-9F0F-5814C7AB8CDC}"/>
              </a:ext>
            </a:extLst>
          </p:cNvPr>
          <p:cNvSpPr txBox="1"/>
          <p:nvPr/>
        </p:nvSpPr>
        <p:spPr>
          <a:xfrm>
            <a:off x="4333891" y="4576221"/>
            <a:ext cx="2387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b</a:t>
            </a:r>
            <a:endParaRPr kumimoji="1" lang="ja-JP" altLang="en-US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99900B92-5F60-7349-8A31-940CE206FD43}"/>
              </a:ext>
            </a:extLst>
          </p:cNvPr>
          <p:cNvSpPr txBox="1"/>
          <p:nvPr/>
        </p:nvSpPr>
        <p:spPr>
          <a:xfrm>
            <a:off x="755164" y="9051401"/>
            <a:ext cx="23639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c</a:t>
            </a:r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0914DF9-2898-BA41-9027-F32BEACCA50D}"/>
              </a:ext>
            </a:extLst>
          </p:cNvPr>
          <p:cNvSpPr txBox="1"/>
          <p:nvPr/>
        </p:nvSpPr>
        <p:spPr>
          <a:xfrm>
            <a:off x="4333890" y="9051401"/>
            <a:ext cx="2387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err="1"/>
              <a:t>Untreat</a:t>
            </a:r>
            <a:r>
              <a:rPr lang="en-US" altLang="ja-JP" dirty="0"/>
              <a:t>, </a:t>
            </a:r>
            <a:r>
              <a:rPr lang="en-US" altLang="ja-JP" dirty="0">
                <a:solidFill>
                  <a:srgbClr val="FF0000"/>
                </a:solidFill>
              </a:rPr>
              <a:t>GPR37L1</a:t>
            </a:r>
            <a:r>
              <a:rPr lang="en-US" altLang="ja-JP" dirty="0"/>
              <a:t>-</a:t>
            </a:r>
            <a:r>
              <a:rPr lang="en-US" altLang="ja-JP" dirty="0">
                <a:solidFill>
                  <a:srgbClr val="00B050"/>
                </a:solidFill>
              </a:rPr>
              <a:t>O4</a:t>
            </a:r>
            <a:r>
              <a:rPr lang="en-US" altLang="ja-JP" dirty="0"/>
              <a:t>-d</a:t>
            </a:r>
            <a:endParaRPr kumimoji="1" lang="ja-JP" altLang="en-US"/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54B59A3D-BE48-954C-8E5D-9B7AD9680FF6}"/>
              </a:ext>
            </a:extLst>
          </p:cNvPr>
          <p:cNvSpPr/>
          <p:nvPr/>
        </p:nvSpPr>
        <p:spPr>
          <a:xfrm>
            <a:off x="0" y="31913"/>
            <a:ext cx="417960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3200" dirty="0"/>
              <a:t>Untreated, </a:t>
            </a:r>
            <a:r>
              <a:rPr lang="en-US" altLang="ja-JP" sz="3200" dirty="0">
                <a:solidFill>
                  <a:srgbClr val="FF0000"/>
                </a:solidFill>
              </a:rPr>
              <a:t>GPR37L1</a:t>
            </a:r>
            <a:r>
              <a:rPr lang="en-US" altLang="ja-JP" sz="3200" dirty="0"/>
              <a:t>-</a:t>
            </a:r>
            <a:r>
              <a:rPr lang="en-US" altLang="ja-JP" sz="3200" dirty="0">
                <a:solidFill>
                  <a:srgbClr val="00B050"/>
                </a:solidFill>
              </a:rPr>
              <a:t>O4</a:t>
            </a:r>
            <a:endParaRPr lang="ja-JP" altLang="en-US" sz="3200"/>
          </a:p>
        </p:txBody>
      </p:sp>
    </p:spTree>
    <p:extLst>
      <p:ext uri="{BB962C8B-B14F-4D97-AF65-F5344CB8AC3E}">
        <p14:creationId xmlns:p14="http://schemas.microsoft.com/office/powerpoint/2010/main" val="3157168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</TotalTime>
  <Words>184</Words>
  <Application>Microsoft Macintosh PowerPoint</Application>
  <PresentationFormat>A4 210 x 297 mm</PresentationFormat>
  <Paragraphs>61</Paragraphs>
  <Slides>1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2</vt:i4>
      </vt:variant>
    </vt:vector>
  </HeadingPairs>
  <TitlesOfParts>
    <vt:vector size="18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19</cp:revision>
  <dcterms:created xsi:type="dcterms:W3CDTF">2020-09-15T05:05:01Z</dcterms:created>
  <dcterms:modified xsi:type="dcterms:W3CDTF">2020-09-15T09:05:32Z</dcterms:modified>
</cp:coreProperties>
</file>